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07CADF-A6CD-43A2-8104-4327D23109C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97BB85-9294-4153-A131-B51BC0B7A4D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597FDE-2A01-4441-9242-DCAD3007E8C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807411-74AE-4156-A758-FC02475B529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568BF1-B125-4833-AE7C-D26356F063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8C9494-9457-4C77-9CBE-FBEF5BF43ED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9EE982-59F2-4C3C-AD1E-623B4A3ADBC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2BE460-4898-414B-BB33-26298D3773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118F65-8CAB-4DC9-B537-EA8C5A025B3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218833-0B4A-42BB-A9BD-9622C2F1042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52585C-1237-4CCE-8B63-B9905ACD985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0843EA-692C-44DB-BC34-6823558996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5E35B05-1EB5-4036-A329-278729B12BD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1293480" y="380880"/>
            <a:ext cx="449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etermination of Kopt for each species</a:t>
            </a:r>
            <a:r>
              <a:rPr b="0" lang="fr-FR" sz="18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457200" y="4724280"/>
            <a:ext cx="61722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900" spc="-1" strike="noStrike">
                <a:solidFill>
                  <a:srgbClr val="000000"/>
                </a:solidFill>
                <a:latin typeface="Arial"/>
              </a:rPr>
              <a:t>pimpi : S. pimpinellifolium; esc : S. lycopersicum; cera : S. lycopersicum var cerasiforme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1563840" y="1143000"/>
            <a:ext cx="3957480" cy="35402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 </cp:lastModifiedBy>
  <dcterms:modified xsi:type="dcterms:W3CDTF">2008-10-03T06:30:04Z</dcterms:modified>
  <cp:revision>1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